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1" r:id="rId3"/>
    <p:sldId id="262" r:id="rId4"/>
    <p:sldId id="260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70" autoAdjust="0"/>
    <p:restoredTop sz="94660"/>
  </p:normalViewPr>
  <p:slideViewPr>
    <p:cSldViewPr snapToGrid="0">
      <p:cViewPr varScale="1">
        <p:scale>
          <a:sx n="59" d="100"/>
          <a:sy n="59" d="100"/>
        </p:scale>
        <p:origin x="15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海邦 平田" userId="c9d39a1ac2a940fa" providerId="LiveId" clId="{43F64371-FCA6-47E5-B8D9-82487DF74FF4}"/>
    <pc:docChg chg="undo custSel addSld delSld modSld">
      <pc:chgData name="海邦 平田" userId="c9d39a1ac2a940fa" providerId="LiveId" clId="{43F64371-FCA6-47E5-B8D9-82487DF74FF4}" dt="2026-02-27T14:51:42.941" v="74" actId="20577"/>
      <pc:docMkLst>
        <pc:docMk/>
      </pc:docMkLst>
      <pc:sldChg chg="addSp delSp modSp add mod">
        <pc:chgData name="海邦 平田" userId="c9d39a1ac2a940fa" providerId="LiveId" clId="{43F64371-FCA6-47E5-B8D9-82487DF74FF4}" dt="2026-01-29T04:41:09.241" v="62" actId="167"/>
        <pc:sldMkLst>
          <pc:docMk/>
          <pc:sldMk cId="1699138701" sldId="257"/>
        </pc:sldMkLst>
        <pc:picChg chg="add mod ord">
          <ac:chgData name="海邦 平田" userId="c9d39a1ac2a940fa" providerId="LiveId" clId="{43F64371-FCA6-47E5-B8D9-82487DF74FF4}" dt="2026-01-29T04:41:09.241" v="62" actId="167"/>
          <ac:picMkLst>
            <pc:docMk/>
            <pc:sldMk cId="1699138701" sldId="257"/>
            <ac:picMk id="3" creationId="{9719F6EB-4F9A-9819-3B41-1F9BB6670ACA}"/>
          </ac:picMkLst>
        </pc:picChg>
      </pc:sldChg>
      <pc:sldChg chg="modSp mod">
        <pc:chgData name="海邦 平田" userId="c9d39a1ac2a940fa" providerId="LiveId" clId="{43F64371-FCA6-47E5-B8D9-82487DF74FF4}" dt="2026-02-27T14:51:42.941" v="74" actId="20577"/>
        <pc:sldMkLst>
          <pc:docMk/>
          <pc:sldMk cId="163360127" sldId="260"/>
        </pc:sldMkLst>
        <pc:spChg chg="mod">
          <ac:chgData name="海邦 平田" userId="c9d39a1ac2a940fa" providerId="LiveId" clId="{43F64371-FCA6-47E5-B8D9-82487DF74FF4}" dt="2026-02-27T14:51:42.941" v="74" actId="20577"/>
          <ac:spMkLst>
            <pc:docMk/>
            <pc:sldMk cId="163360127" sldId="260"/>
            <ac:spMk id="3" creationId="{A0D1EA12-B69E-B2C6-ABD3-60E54B5804AB}"/>
          </ac:spMkLst>
        </pc:spChg>
      </pc:sldChg>
      <pc:sldChg chg="addSp modSp add mod">
        <pc:chgData name="海邦 平田" userId="c9d39a1ac2a940fa" providerId="LiveId" clId="{43F64371-FCA6-47E5-B8D9-82487DF74FF4}" dt="2026-01-29T04:40:58.351" v="55" actId="167"/>
        <pc:sldMkLst>
          <pc:docMk/>
          <pc:sldMk cId="3387823673" sldId="261"/>
        </pc:sldMkLst>
        <pc:spChg chg="mod">
          <ac:chgData name="海邦 平田" userId="c9d39a1ac2a940fa" providerId="LiveId" clId="{43F64371-FCA6-47E5-B8D9-82487DF74FF4}" dt="2026-01-29T04:40:10.566" v="37" actId="20577"/>
          <ac:spMkLst>
            <pc:docMk/>
            <pc:sldMk cId="3387823673" sldId="261"/>
            <ac:spMk id="7" creationId="{C0B3CD92-E117-0291-B2A4-80150FE2F379}"/>
          </ac:spMkLst>
        </pc:spChg>
        <pc:picChg chg="add mod ord">
          <ac:chgData name="海邦 平田" userId="c9d39a1ac2a940fa" providerId="LiveId" clId="{43F64371-FCA6-47E5-B8D9-82487DF74FF4}" dt="2026-01-29T04:40:58.351" v="55" actId="167"/>
          <ac:picMkLst>
            <pc:docMk/>
            <pc:sldMk cId="3387823673" sldId="261"/>
            <ac:picMk id="3" creationId="{40E6CA2D-7DA2-E649-EBC5-A2ABC504F9AB}"/>
          </ac:picMkLst>
        </pc:picChg>
      </pc:sldChg>
      <pc:sldChg chg="addSp modSp add mod">
        <pc:chgData name="海邦 平田" userId="c9d39a1ac2a940fa" providerId="LiveId" clId="{43F64371-FCA6-47E5-B8D9-82487DF74FF4}" dt="2026-01-29T04:40:48.439" v="48" actId="167"/>
        <pc:sldMkLst>
          <pc:docMk/>
          <pc:sldMk cId="3569821371" sldId="262"/>
        </pc:sldMkLst>
        <pc:spChg chg="mod">
          <ac:chgData name="海邦 平田" userId="c9d39a1ac2a940fa" providerId="LiveId" clId="{43F64371-FCA6-47E5-B8D9-82487DF74FF4}" dt="2026-01-29T04:40:36.582" v="42" actId="20577"/>
          <ac:spMkLst>
            <pc:docMk/>
            <pc:sldMk cId="3569821371" sldId="262"/>
            <ac:spMk id="7" creationId="{AC3D7778-5F10-6A23-1583-83BD5AE1E50F}"/>
          </ac:spMkLst>
        </pc:spChg>
        <pc:picChg chg="add mod ord">
          <ac:chgData name="海邦 平田" userId="c9d39a1ac2a940fa" providerId="LiveId" clId="{43F64371-FCA6-47E5-B8D9-82487DF74FF4}" dt="2026-01-29T04:40:48.439" v="48" actId="167"/>
          <ac:picMkLst>
            <pc:docMk/>
            <pc:sldMk cId="3569821371" sldId="262"/>
            <ac:picMk id="3" creationId="{81DAEC04-DA84-E01B-5B59-8980946EFE3C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4C23A6-B409-1FDD-B29A-5EDE2015E6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BDDAC24-7DDA-423A-3FE3-F817C79A30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3AD14B-A669-B062-1B16-521DFC128B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6C72-4F1C-42AE-A6D8-201A0DFF3A79}" type="datetimeFigureOut">
              <a:rPr kumimoji="1" lang="ja-JP" altLang="en-US" smtClean="0"/>
              <a:t>2026/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4DD841D-711C-AD38-6527-75DE70EF9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6EC1CD-A4A7-33C3-CC68-5DD7CCE06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A757E-5C09-47A0-8334-2E3644CAF4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5253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F50065-CD7C-D541-3C73-AA418C4195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843B18C-7381-0F5D-F135-BF9AB46EA7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91CEEE4-A781-6EBB-C36C-5BEE11184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6C72-4F1C-42AE-A6D8-201A0DFF3A79}" type="datetimeFigureOut">
              <a:rPr kumimoji="1" lang="ja-JP" altLang="en-US" smtClean="0"/>
              <a:t>2026/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ABCF951-C23B-9C3E-EEDC-5174A4222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B98B25E-F442-6A45-5C88-D5EFC426B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A757E-5C09-47A0-8334-2E3644CAF4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2538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72255D7-A39C-F9CA-9522-5BEE45D03F1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BC01626-F8C2-27DD-9FA5-52D63794E3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AECB970-9E6E-4E2D-B9CD-2D580C01F9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6C72-4F1C-42AE-A6D8-201A0DFF3A79}" type="datetimeFigureOut">
              <a:rPr kumimoji="1" lang="ja-JP" altLang="en-US" smtClean="0"/>
              <a:t>2026/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24CF1E-1C71-6874-15B7-F7CDE6E0D1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B589C1B-9C2A-E9F7-DA48-C425110D51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A757E-5C09-47A0-8334-2E3644CAF4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9029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54C30C-D609-C442-0827-AEE466CB4E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6E578D8-8DBC-7E44-7E95-EDB2FE1A10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17AA980-A8D0-E2FC-1BAE-B94A9AB3D0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6C72-4F1C-42AE-A6D8-201A0DFF3A79}" type="datetimeFigureOut">
              <a:rPr kumimoji="1" lang="ja-JP" altLang="en-US" smtClean="0"/>
              <a:t>2026/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728267-A8A0-8A80-0823-229E751EC0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A9688F1-C7D7-860F-CEE9-7B472B457C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A757E-5C09-47A0-8334-2E3644CAF4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9419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25C4C1D-9A42-6F5C-E8DF-2E118ABA78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D598B82-6EA5-33C1-794C-7A6932F746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E0DAEBE-1EFD-DEE5-9325-D2E893CA6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6C72-4F1C-42AE-A6D8-201A0DFF3A79}" type="datetimeFigureOut">
              <a:rPr kumimoji="1" lang="ja-JP" altLang="en-US" smtClean="0"/>
              <a:t>2026/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E87984-01CC-206C-D827-6E176CE16C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C7B4EF6-5091-5F51-78C7-77D71B8E3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A757E-5C09-47A0-8334-2E3644CAF4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569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4912F4-DE02-3A46-A587-6016622647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BEFE6FA-0202-B0A9-74F8-00EF86A287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334A52D-0953-042D-F7D4-75C0F96C54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540157E-EB4D-E3B5-FB30-71143319C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6C72-4F1C-42AE-A6D8-201A0DFF3A79}" type="datetimeFigureOut">
              <a:rPr kumimoji="1" lang="ja-JP" altLang="en-US" smtClean="0"/>
              <a:t>2026/2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3E66B00-F09A-041A-5492-FBA418A730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F7E74F-046B-2AC6-BFE4-C66AE0E2CF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A757E-5C09-47A0-8334-2E3644CAF4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7578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6EC61B-1168-39E0-3DBC-F40F7A4596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1A7D847-0C3D-F61F-B894-D2AF387B9D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95880E5-55B5-5D02-F7EA-FD8A735718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8D0E3EE-F684-7662-1F38-3C080717D9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1A7BCEE-0283-D2C0-9E2E-810995B213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810A72D-0F3C-0CF9-92F8-FA81590E2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6C72-4F1C-42AE-A6D8-201A0DFF3A79}" type="datetimeFigureOut">
              <a:rPr kumimoji="1" lang="ja-JP" altLang="en-US" smtClean="0"/>
              <a:t>2026/2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E7475E1-B43F-2E64-4239-106889ACC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0BEF744-5930-60D2-967C-4807DB660E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A757E-5C09-47A0-8334-2E3644CAF4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45368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2030D4-2603-4A0B-0350-153D922E2A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862895C-3F88-DC9B-2126-57F55833D7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6C72-4F1C-42AE-A6D8-201A0DFF3A79}" type="datetimeFigureOut">
              <a:rPr kumimoji="1" lang="ja-JP" altLang="en-US" smtClean="0"/>
              <a:t>2026/2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E9E4F2A-0F4E-AF8D-42CB-482896A377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10FA4F4-D2A1-DEFD-420E-ACDF91113D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A757E-5C09-47A0-8334-2E3644CAF4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621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B1F5E5F-E29F-2935-96EC-F5DED561C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6C72-4F1C-42AE-A6D8-201A0DFF3A79}" type="datetimeFigureOut">
              <a:rPr kumimoji="1" lang="ja-JP" altLang="en-US" smtClean="0"/>
              <a:t>2026/2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CC16570-EF93-DDF1-4635-14EB2AE3DA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530E4BF-F744-55E4-A866-14EF537096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A757E-5C09-47A0-8334-2E3644CAF4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15407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2146CB8-581F-78C8-1AA8-EBE36AAF82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DD48AEF-C548-A2A8-43F2-69BFDA9EF0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9463F3F-F997-9D20-4DE6-DEB9835F01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B0E9D23-24B8-1468-2FC3-34DFDEC0B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6C72-4F1C-42AE-A6D8-201A0DFF3A79}" type="datetimeFigureOut">
              <a:rPr kumimoji="1" lang="ja-JP" altLang="en-US" smtClean="0"/>
              <a:t>2026/2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D26AB8A-F821-E2D9-AE3A-44D753DD1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56DFC8A-0259-0ADC-9BD5-BA2E24623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A757E-5C09-47A0-8334-2E3644CAF4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7232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E3C77F-9B78-2607-E724-F10CB5C70C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ECE3F27-21BE-6765-1F16-7D91DCB20B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644B74D-9C57-B458-1828-0472F5373A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78A068E-12A0-F4FE-2641-4CDDF61C31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6C72-4F1C-42AE-A6D8-201A0DFF3A79}" type="datetimeFigureOut">
              <a:rPr kumimoji="1" lang="ja-JP" altLang="en-US" smtClean="0"/>
              <a:t>2026/2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817426F-231B-AD3A-39C8-706CE2359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BF39142-094D-BF61-969C-BEB11B0C2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A757E-5C09-47A0-8334-2E3644CAF4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0528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B9ED012-4692-1882-5CE1-4D1DB90F25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54D69C8-1C82-FCD2-FC2E-48219C16D8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0BE0EB-FDA2-6BA3-1B60-438DB13533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F6C72-4F1C-42AE-A6D8-201A0DFF3A79}" type="datetimeFigureOut">
              <a:rPr kumimoji="1" lang="ja-JP" altLang="en-US" smtClean="0"/>
              <a:t>2026/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BF0E1E-4FCA-7D73-55D1-11153876DD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7D73051-105D-B044-C98D-CB5A85795E8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3A757E-5C09-47A0-8334-2E3644CAF4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304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9719F6EB-4F9A-9819-3B41-1F9BB6670A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561" y="115537"/>
            <a:ext cx="11044878" cy="6626927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9C615DA-6DB2-CAFA-1662-7E83E6337F66}"/>
              </a:ext>
            </a:extLst>
          </p:cNvPr>
          <p:cNvSpPr txBox="1"/>
          <p:nvPr/>
        </p:nvSpPr>
        <p:spPr>
          <a:xfrm>
            <a:off x="5069681" y="6488668"/>
            <a:ext cx="20526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Group 1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91387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9FA1B9A-ED7B-7A24-2E39-844D1712BC9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40E6CA2D-7DA2-E649-EBC5-A2ABC504F9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561" y="115537"/>
            <a:ext cx="11044878" cy="6626927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0B3CD92-E117-0291-B2A4-80150FE2F379}"/>
              </a:ext>
            </a:extLst>
          </p:cNvPr>
          <p:cNvSpPr txBox="1"/>
          <p:nvPr/>
        </p:nvSpPr>
        <p:spPr>
          <a:xfrm>
            <a:off x="5069681" y="6488668"/>
            <a:ext cx="20526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Group 2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78236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841CED4-D12B-C9CD-59B3-79DED46FD6D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81DAEC04-DA84-E01B-5B59-8980946EFE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561" y="115537"/>
            <a:ext cx="11044878" cy="6626927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C3D7778-5F10-6A23-1583-83BD5AE1E50F}"/>
              </a:ext>
            </a:extLst>
          </p:cNvPr>
          <p:cNvSpPr txBox="1"/>
          <p:nvPr/>
        </p:nvSpPr>
        <p:spPr>
          <a:xfrm>
            <a:off x="5069681" y="6488668"/>
            <a:ext cx="20526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Group 3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98213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15C7D89-83BE-6081-E2E1-16E6B47BF5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legend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0D1EA12-B69E-B2C6-ABD3-60E54B5804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kumimoji="1"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Kernel density plots of transportation time for each group before and after the COVID-19 pandemic. </a:t>
            </a:r>
          </a:p>
        </p:txBody>
      </p:sp>
    </p:spTree>
    <p:extLst>
      <p:ext uri="{BB962C8B-B14F-4D97-AF65-F5344CB8AC3E}">
        <p14:creationId xmlns:p14="http://schemas.microsoft.com/office/powerpoint/2010/main" val="163360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33</Words>
  <Application>Microsoft Office PowerPoint</Application>
  <PresentationFormat>ワイド画面</PresentationFormat>
  <Paragraphs>5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Figure legend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海邦 平田</dc:creator>
  <cp:lastModifiedBy>Kaiho Hirata</cp:lastModifiedBy>
  <cp:revision>1</cp:revision>
  <dcterms:created xsi:type="dcterms:W3CDTF">2024-11-24T20:44:52Z</dcterms:created>
  <dcterms:modified xsi:type="dcterms:W3CDTF">2026-02-27T14:51:45Z</dcterms:modified>
</cp:coreProperties>
</file>